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71236F-89E0-43A4-A5A3-A217348064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A1AC41-30CD-425A-9801-297F014F6F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3F0089-4C57-42BA-86FE-91FD3000EE1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7E64F4-1F28-4A68-8A5F-94AA0C1EF7D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B7E305-2E09-4D1A-BA00-E198B1F34E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355105-E2CD-45B8-A37E-37CD67BE90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8A4177-0DA9-4DAD-BB9E-4F64A7623B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1431F9-C2B7-4E1D-A29E-7D163EF95C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D23F3D-CBDA-4070-A753-60F3A3BA69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1EF85F-B1DB-4D93-9D89-D3ED750F92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36640C-4A5D-469F-A6DA-793F94C138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912D63-7E88-4049-9CB1-D8C0512D3D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7AB9B7-12BA-4FBD-8CAD-1755A35680F6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88920" y="149400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Day 7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54720" y="2387520"/>
            <a:ext cx="50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Day 1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35640" y="3236760"/>
            <a:ext cx="50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Day 17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35640" y="4167360"/>
            <a:ext cx="50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Day 27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487440" y="1057320"/>
            <a:ext cx="2889000" cy="463536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729720" y="798480"/>
            <a:ext cx="52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vector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1793880" y="79848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Npn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2628720" y="798480"/>
            <a:ext cx="61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Npnt</a:t>
            </a:r>
            <a:r>
              <a:rPr b="0" lang="en-CA" sz="1000" spc="-1" strike="noStrike">
                <a:solidFill>
                  <a:srgbClr val="000000"/>
                </a:solidFill>
                <a:latin typeface="Arial"/>
                <a:ea typeface="宋体"/>
              </a:rPr>
              <a:t>+3’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38520" y="5137200"/>
            <a:ext cx="50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Day 5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50" name="" descr=""/>
          <p:cNvPicPr/>
          <p:nvPr/>
        </p:nvPicPr>
        <p:blipFill>
          <a:blip r:embed="rId2"/>
          <a:stretch/>
        </p:blipFill>
        <p:spPr>
          <a:xfrm>
            <a:off x="3943440" y="1012680"/>
            <a:ext cx="2889000" cy="85896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3472560" y="1457280"/>
            <a:ext cx="50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Day 5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74520" y="6253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2000" spc="-1" strike="noStrike">
                <a:solidFill>
                  <a:srgbClr val="000000"/>
                </a:solidFill>
                <a:latin typeface="Arial"/>
                <a:ea typeface="PMingLiU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3510000" y="62388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2000" spc="-1" strike="noStrike">
                <a:solidFill>
                  <a:srgbClr val="000000"/>
                </a:solidFill>
                <a:latin typeface="Arial"/>
                <a:ea typeface="PMingLiU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4158720" y="752400"/>
            <a:ext cx="52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vector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5222880" y="75240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Npn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6057720" y="752400"/>
            <a:ext cx="61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Npnt</a:t>
            </a:r>
            <a:r>
              <a:rPr b="0" lang="en-CA" sz="1000" spc="-1" strike="noStrike">
                <a:solidFill>
                  <a:srgbClr val="000000"/>
                </a:solidFill>
                <a:latin typeface="Arial"/>
                <a:ea typeface="宋体"/>
              </a:rPr>
              <a:t>+3’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3574800" y="203976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2000" spc="-1" strike="noStrike">
                <a:solidFill>
                  <a:srgbClr val="000000"/>
                </a:solidFill>
                <a:latin typeface="Arial"/>
                <a:ea typeface="PMingLiU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4535640" y="3876840"/>
            <a:ext cx="86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0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5135400" y="38768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5718600" y="38768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6332760" y="38768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4272120" y="37339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4197240" y="293544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5339160" y="4038480"/>
            <a:ext cx="26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day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 rot="16200000">
            <a:off x="3325320" y="2991600"/>
            <a:ext cx="1369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Cell number (x 10</a:t>
            </a:r>
            <a:r>
              <a:rPr b="0" lang="en-CA" sz="1000" spc="-1" strike="noStrike" baseline="30000">
                <a:solidFill>
                  <a:srgbClr val="000000"/>
                </a:solidFill>
                <a:latin typeface="Arial"/>
              </a:rPr>
              <a:t>5</a:t>
            </a: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 cells)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4197240" y="333216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4197240" y="214776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2.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4197240" y="254484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1.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4506840" y="60292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5116680" y="60292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5689800" y="60292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6299640" y="60292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4278240" y="59403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4278240" y="53928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4278240" y="48513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4278240" y="43084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5347080" y="6186600"/>
            <a:ext cx="26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day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 flipV="1">
            <a:off x="4556160" y="3803400"/>
            <a:ext cx="1440" cy="44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 flipV="1">
            <a:off x="4865760" y="3803400"/>
            <a:ext cx="0" cy="21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 flipV="1">
            <a:off x="5172120" y="3803400"/>
            <a:ext cx="1440" cy="44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 flipV="1">
            <a:off x="5479920" y="3803400"/>
            <a:ext cx="1800" cy="21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 flipV="1">
            <a:off x="5788080" y="3803400"/>
            <a:ext cx="3240" cy="44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 flipV="1">
            <a:off x="6099120" y="3803400"/>
            <a:ext cx="0" cy="21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 flipV="1">
            <a:off x="6407280" y="3803400"/>
            <a:ext cx="1440" cy="44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4432320" y="3803760"/>
            <a:ext cx="20970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4398840" y="3803760"/>
            <a:ext cx="334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4416480" y="3408480"/>
            <a:ext cx="158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4398840" y="3014640"/>
            <a:ext cx="334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4416480" y="2620800"/>
            <a:ext cx="158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4398840" y="2227320"/>
            <a:ext cx="334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 flipV="1">
            <a:off x="4432320" y="2188800"/>
            <a:ext cx="4680" cy="16146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6529320" y="3803760"/>
            <a:ext cx="18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 flipH="1">
            <a:off x="4614480" y="3741840"/>
            <a:ext cx="37620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 flipH="1">
            <a:off x="5103360" y="3533760"/>
            <a:ext cx="384120" cy="1778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 flipH="1">
            <a:off x="5590800" y="3191040"/>
            <a:ext cx="273240" cy="2728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 flipH="1">
            <a:off x="5969160" y="2919240"/>
            <a:ext cx="382320" cy="1969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4521240" y="3735360"/>
            <a:ext cx="68400" cy="9684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5014800" y="3687840"/>
            <a:ext cx="69840" cy="9504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5508720" y="3459240"/>
            <a:ext cx="69840" cy="9684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5880240" y="3097080"/>
            <a:ext cx="66600" cy="9540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6372360" y="2841480"/>
            <a:ext cx="69840" cy="9864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 flipH="1">
            <a:off x="4611600" y="3697200"/>
            <a:ext cx="379440" cy="748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 flipH="1">
            <a:off x="5095440" y="3246480"/>
            <a:ext cx="399960" cy="3920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 flipH="1">
            <a:off x="5590800" y="2862360"/>
            <a:ext cx="274680" cy="2887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 flipH="1">
            <a:off x="5970600" y="2633760"/>
            <a:ext cx="379440" cy="1537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4521240" y="3735360"/>
            <a:ext cx="68400" cy="9684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5014800" y="3638520"/>
            <a:ext cx="69840" cy="9684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5508720" y="3152880"/>
            <a:ext cx="69840" cy="9684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5880240" y="2762280"/>
            <a:ext cx="66600" cy="9684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6372360" y="2558880"/>
            <a:ext cx="69840" cy="9684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 flipV="1">
            <a:off x="5049720" y="3687840"/>
            <a:ext cx="0" cy="475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5000760" y="3735360"/>
            <a:ext cx="9684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5049720" y="3736800"/>
            <a:ext cx="0" cy="460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5000760" y="3736800"/>
            <a:ext cx="96840" cy="50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 flipV="1">
            <a:off x="5543640" y="3459240"/>
            <a:ext cx="1440" cy="381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5492880" y="3497400"/>
            <a:ext cx="98280" cy="46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5543640" y="3524400"/>
            <a:ext cx="1440" cy="316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5492880" y="3524400"/>
            <a:ext cx="9828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5911920" y="3087720"/>
            <a:ext cx="1440" cy="93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5864400" y="3087720"/>
            <a:ext cx="96840" cy="46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 flipV="1">
            <a:off x="5911920" y="3192480"/>
            <a:ext cx="1440" cy="79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>
            <a:off x="5864400" y="3200400"/>
            <a:ext cx="96840" cy="46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6407280" y="2776680"/>
            <a:ext cx="1440" cy="64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000" bIns="18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>
            <a:off x="6357960" y="2776680"/>
            <a:ext cx="982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 flipV="1">
            <a:off x="6407280" y="2940120"/>
            <a:ext cx="1440" cy="619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6357960" y="3002040"/>
            <a:ext cx="98280" cy="32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 flipV="1">
            <a:off x="5049720" y="3638160"/>
            <a:ext cx="0" cy="349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>
            <a:off x="5000760" y="3673440"/>
            <a:ext cx="9684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>
            <a:off x="5049720" y="3699000"/>
            <a:ext cx="0" cy="363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>
            <a:off x="5000760" y="3699000"/>
            <a:ext cx="96840" cy="28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 flipV="1">
            <a:off x="5543640" y="3152880"/>
            <a:ext cx="1440" cy="252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5492880" y="3178080"/>
            <a:ext cx="98280" cy="32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5543640" y="3225960"/>
            <a:ext cx="1440" cy="237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>
            <a:off x="5492880" y="3225960"/>
            <a:ext cx="9828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>
            <a:off x="5911920" y="2754360"/>
            <a:ext cx="1440" cy="79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>
            <a:off x="5864400" y="2754360"/>
            <a:ext cx="96840" cy="32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 flipV="1">
            <a:off x="5911920" y="2859120"/>
            <a:ext cx="1440" cy="64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5864400" y="2865600"/>
            <a:ext cx="96840" cy="28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>
            <a:off x="6407280" y="2530440"/>
            <a:ext cx="1440" cy="28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>
            <a:off x="6357960" y="2530440"/>
            <a:ext cx="98280" cy="1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 flipV="1">
            <a:off x="6407280" y="2655360"/>
            <a:ext cx="1440" cy="320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"/>
          <p:cNvSpPr/>
          <p:nvPr/>
        </p:nvSpPr>
        <p:spPr>
          <a:xfrm>
            <a:off x="6357960" y="2687760"/>
            <a:ext cx="98280" cy="28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>
            <a:off x="4865040" y="2340000"/>
            <a:ext cx="473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+ miR-37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>
            <a:off x="4856400" y="2536920"/>
            <a:ext cx="367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+ vector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"/>
          <p:cNvSpPr/>
          <p:nvPr/>
        </p:nvSpPr>
        <p:spPr>
          <a:xfrm>
            <a:off x="4708440" y="2530440"/>
            <a:ext cx="69840" cy="9864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>
            <a:off x="4714920" y="2346480"/>
            <a:ext cx="68040" cy="9504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"/>
          <p:cNvSpPr/>
          <p:nvPr/>
        </p:nvSpPr>
        <p:spPr>
          <a:xfrm>
            <a:off x="5711400" y="2563920"/>
            <a:ext cx="24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Black"/>
                <a:ea typeface="宋体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"/>
          <p:cNvSpPr/>
          <p:nvPr/>
        </p:nvSpPr>
        <p:spPr>
          <a:xfrm>
            <a:off x="6248160" y="2320920"/>
            <a:ext cx="24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Black"/>
                <a:ea typeface="宋体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"/>
          <p:cNvSpPr/>
          <p:nvPr/>
        </p:nvSpPr>
        <p:spPr>
          <a:xfrm flipV="1">
            <a:off x="4554360" y="5973840"/>
            <a:ext cx="1800" cy="31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"/>
          <p:cNvSpPr/>
          <p:nvPr/>
        </p:nvSpPr>
        <p:spPr>
          <a:xfrm flipV="1">
            <a:off x="4859280" y="5973840"/>
            <a:ext cx="1800" cy="15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 flipV="1">
            <a:off x="5162400" y="5973840"/>
            <a:ext cx="1800" cy="31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 flipV="1">
            <a:off x="5465880" y="5973840"/>
            <a:ext cx="2880" cy="15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 flipV="1">
            <a:off x="5772240" y="5973840"/>
            <a:ext cx="1440" cy="31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 flipV="1">
            <a:off x="6073920" y="5973840"/>
            <a:ext cx="2880" cy="15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 flipV="1">
            <a:off x="6380280" y="5973840"/>
            <a:ext cx="1440" cy="31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"/>
          <p:cNvSpPr/>
          <p:nvPr/>
        </p:nvSpPr>
        <p:spPr>
          <a:xfrm>
            <a:off x="4433760" y="5973840"/>
            <a:ext cx="206856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"/>
          <p:cNvSpPr/>
          <p:nvPr/>
        </p:nvSpPr>
        <p:spPr>
          <a:xfrm>
            <a:off x="4400640" y="5973840"/>
            <a:ext cx="3312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"/>
          <p:cNvSpPr/>
          <p:nvPr/>
        </p:nvSpPr>
        <p:spPr>
          <a:xfrm>
            <a:off x="4417920" y="5702400"/>
            <a:ext cx="158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"/>
          <p:cNvSpPr/>
          <p:nvPr/>
        </p:nvSpPr>
        <p:spPr>
          <a:xfrm>
            <a:off x="4400640" y="5429160"/>
            <a:ext cx="331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"/>
          <p:cNvSpPr/>
          <p:nvPr/>
        </p:nvSpPr>
        <p:spPr>
          <a:xfrm>
            <a:off x="4417920" y="5160960"/>
            <a:ext cx="158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"/>
          <p:cNvSpPr/>
          <p:nvPr/>
        </p:nvSpPr>
        <p:spPr>
          <a:xfrm>
            <a:off x="4400640" y="4888080"/>
            <a:ext cx="3312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"/>
          <p:cNvSpPr/>
          <p:nvPr/>
        </p:nvSpPr>
        <p:spPr>
          <a:xfrm>
            <a:off x="4417920" y="4618080"/>
            <a:ext cx="158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"/>
          <p:cNvSpPr/>
          <p:nvPr/>
        </p:nvSpPr>
        <p:spPr>
          <a:xfrm>
            <a:off x="4400640" y="4344840"/>
            <a:ext cx="3312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"/>
          <p:cNvSpPr/>
          <p:nvPr/>
        </p:nvSpPr>
        <p:spPr>
          <a:xfrm flipV="1">
            <a:off x="4433760" y="4344480"/>
            <a:ext cx="1800" cy="1629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"/>
          <p:cNvSpPr/>
          <p:nvPr/>
        </p:nvSpPr>
        <p:spPr>
          <a:xfrm>
            <a:off x="6502320" y="5973840"/>
            <a:ext cx="180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"/>
          <p:cNvSpPr/>
          <p:nvPr/>
        </p:nvSpPr>
        <p:spPr>
          <a:xfrm flipH="1">
            <a:off x="4613040" y="5956200"/>
            <a:ext cx="369720" cy="32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"/>
          <p:cNvSpPr/>
          <p:nvPr/>
        </p:nvSpPr>
        <p:spPr>
          <a:xfrm flipH="1">
            <a:off x="5097600" y="5864400"/>
            <a:ext cx="372960" cy="777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"/>
          <p:cNvSpPr/>
          <p:nvPr/>
        </p:nvSpPr>
        <p:spPr>
          <a:xfrm flipH="1">
            <a:off x="5559480" y="5378400"/>
            <a:ext cx="301680" cy="4287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"/>
          <p:cNvSpPr/>
          <p:nvPr/>
        </p:nvSpPr>
        <p:spPr>
          <a:xfrm flipH="1">
            <a:off x="5924160" y="4633920"/>
            <a:ext cx="423720" cy="6508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"/>
          <p:cNvSpPr/>
          <p:nvPr/>
        </p:nvSpPr>
        <p:spPr>
          <a:xfrm>
            <a:off x="4514760" y="5921280"/>
            <a:ext cx="76320" cy="77760"/>
          </a:xfrm>
          <a:prstGeom prst="ellipse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"/>
          <p:cNvSpPr/>
          <p:nvPr/>
        </p:nvSpPr>
        <p:spPr>
          <a:xfrm>
            <a:off x="5003640" y="5916600"/>
            <a:ext cx="76320" cy="76320"/>
          </a:xfrm>
          <a:prstGeom prst="ellipse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"/>
          <p:cNvSpPr/>
          <p:nvPr/>
        </p:nvSpPr>
        <p:spPr>
          <a:xfrm>
            <a:off x="5487840" y="5815080"/>
            <a:ext cx="79560" cy="75960"/>
          </a:xfrm>
          <a:prstGeom prst="ellipse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6840" bIns="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"/>
          <p:cNvSpPr/>
          <p:nvPr/>
        </p:nvSpPr>
        <p:spPr>
          <a:xfrm>
            <a:off x="5854680" y="5292720"/>
            <a:ext cx="77760" cy="76320"/>
          </a:xfrm>
          <a:prstGeom prst="ellipse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"/>
          <p:cNvSpPr/>
          <p:nvPr/>
        </p:nvSpPr>
        <p:spPr>
          <a:xfrm>
            <a:off x="6340320" y="4548240"/>
            <a:ext cx="78120" cy="76320"/>
          </a:xfrm>
          <a:prstGeom prst="ellipse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"/>
          <p:cNvSpPr/>
          <p:nvPr/>
        </p:nvSpPr>
        <p:spPr>
          <a:xfrm flipH="1">
            <a:off x="4613040" y="5942160"/>
            <a:ext cx="369720" cy="140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"/>
          <p:cNvSpPr/>
          <p:nvPr/>
        </p:nvSpPr>
        <p:spPr>
          <a:xfrm flipH="1">
            <a:off x="5097600" y="5877000"/>
            <a:ext cx="372960" cy="540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"/>
          <p:cNvSpPr/>
          <p:nvPr/>
        </p:nvSpPr>
        <p:spPr>
          <a:xfrm flipH="1">
            <a:off x="5565240" y="5504040"/>
            <a:ext cx="289080" cy="3222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"/>
          <p:cNvSpPr/>
          <p:nvPr/>
        </p:nvSpPr>
        <p:spPr>
          <a:xfrm flipH="1">
            <a:off x="5943600" y="5214960"/>
            <a:ext cx="387360" cy="2188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"/>
          <p:cNvSpPr/>
          <p:nvPr/>
        </p:nvSpPr>
        <p:spPr>
          <a:xfrm>
            <a:off x="4514760" y="5921280"/>
            <a:ext cx="76320" cy="77760"/>
          </a:xfrm>
          <a:prstGeom prst="ellipse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"/>
          <p:cNvSpPr/>
          <p:nvPr/>
        </p:nvSpPr>
        <p:spPr>
          <a:xfrm>
            <a:off x="5003640" y="5900760"/>
            <a:ext cx="76320" cy="76320"/>
          </a:xfrm>
          <a:prstGeom prst="ellipse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"/>
          <p:cNvSpPr/>
          <p:nvPr/>
        </p:nvSpPr>
        <p:spPr>
          <a:xfrm>
            <a:off x="5487840" y="5830920"/>
            <a:ext cx="79560" cy="76320"/>
          </a:xfrm>
          <a:prstGeom prst="ellipse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"/>
          <p:cNvSpPr/>
          <p:nvPr/>
        </p:nvSpPr>
        <p:spPr>
          <a:xfrm>
            <a:off x="5854680" y="5424480"/>
            <a:ext cx="77760" cy="76320"/>
          </a:xfrm>
          <a:prstGeom prst="ellipse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"/>
          <p:cNvSpPr/>
          <p:nvPr/>
        </p:nvSpPr>
        <p:spPr>
          <a:xfrm>
            <a:off x="6340320" y="5148360"/>
            <a:ext cx="78120" cy="75960"/>
          </a:xfrm>
          <a:prstGeom prst="ellipse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6840" bIns="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"/>
          <p:cNvSpPr/>
          <p:nvPr/>
        </p:nvSpPr>
        <p:spPr>
          <a:xfrm flipV="1">
            <a:off x="5040360" y="5917680"/>
            <a:ext cx="3240" cy="349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"/>
          <p:cNvSpPr/>
          <p:nvPr/>
        </p:nvSpPr>
        <p:spPr>
          <a:xfrm>
            <a:off x="4992840" y="5952960"/>
            <a:ext cx="96840" cy="32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"/>
          <p:cNvSpPr/>
          <p:nvPr/>
        </p:nvSpPr>
        <p:spPr>
          <a:xfrm>
            <a:off x="5040360" y="5956200"/>
            <a:ext cx="3240" cy="349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"/>
          <p:cNvSpPr/>
          <p:nvPr/>
        </p:nvSpPr>
        <p:spPr>
          <a:xfrm>
            <a:off x="4992840" y="5956200"/>
            <a:ext cx="96840" cy="32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"/>
          <p:cNvSpPr/>
          <p:nvPr/>
        </p:nvSpPr>
        <p:spPr>
          <a:xfrm flipV="1">
            <a:off x="5529240" y="5816520"/>
            <a:ext cx="1440" cy="158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9" name=""/>
          <p:cNvSpPr/>
          <p:nvPr/>
        </p:nvSpPr>
        <p:spPr>
          <a:xfrm>
            <a:off x="5479920" y="5832360"/>
            <a:ext cx="96840" cy="32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0" name=""/>
          <p:cNvSpPr/>
          <p:nvPr/>
        </p:nvSpPr>
        <p:spPr>
          <a:xfrm>
            <a:off x="5529240" y="5873760"/>
            <a:ext cx="1440" cy="158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1" name=""/>
          <p:cNvSpPr/>
          <p:nvPr/>
        </p:nvSpPr>
        <p:spPr>
          <a:xfrm>
            <a:off x="5479920" y="5873760"/>
            <a:ext cx="9684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"/>
          <p:cNvSpPr/>
          <p:nvPr/>
        </p:nvSpPr>
        <p:spPr>
          <a:xfrm flipV="1">
            <a:off x="5891040" y="5293800"/>
            <a:ext cx="3240" cy="1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3" name=""/>
          <p:cNvSpPr/>
          <p:nvPr/>
        </p:nvSpPr>
        <p:spPr>
          <a:xfrm>
            <a:off x="5843520" y="5295960"/>
            <a:ext cx="98640" cy="32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4" name=""/>
          <p:cNvSpPr/>
          <p:nvPr/>
        </p:nvSpPr>
        <p:spPr>
          <a:xfrm>
            <a:off x="5891040" y="5365800"/>
            <a:ext cx="324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5" name=""/>
          <p:cNvSpPr/>
          <p:nvPr/>
        </p:nvSpPr>
        <p:spPr>
          <a:xfrm>
            <a:off x="5843520" y="5365800"/>
            <a:ext cx="9864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6" name=""/>
          <p:cNvSpPr/>
          <p:nvPr/>
        </p:nvSpPr>
        <p:spPr>
          <a:xfrm>
            <a:off x="6380280" y="4414680"/>
            <a:ext cx="1440" cy="1350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"/>
          <p:cNvSpPr/>
          <p:nvPr/>
        </p:nvSpPr>
        <p:spPr>
          <a:xfrm>
            <a:off x="6332400" y="4414680"/>
            <a:ext cx="96840" cy="1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8" name=""/>
          <p:cNvSpPr/>
          <p:nvPr/>
        </p:nvSpPr>
        <p:spPr>
          <a:xfrm flipV="1">
            <a:off x="6380280" y="4622760"/>
            <a:ext cx="1440" cy="1382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9" name=""/>
          <p:cNvSpPr/>
          <p:nvPr/>
        </p:nvSpPr>
        <p:spPr>
          <a:xfrm>
            <a:off x="6332400" y="4761000"/>
            <a:ext cx="9684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"/>
          <p:cNvSpPr/>
          <p:nvPr/>
        </p:nvSpPr>
        <p:spPr>
          <a:xfrm flipV="1">
            <a:off x="5040360" y="5900760"/>
            <a:ext cx="3240" cy="316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"/>
          <p:cNvSpPr/>
          <p:nvPr/>
        </p:nvSpPr>
        <p:spPr>
          <a:xfrm>
            <a:off x="4992840" y="5932440"/>
            <a:ext cx="96840" cy="1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2" name=""/>
          <p:cNvSpPr/>
          <p:nvPr/>
        </p:nvSpPr>
        <p:spPr>
          <a:xfrm>
            <a:off x="5040360" y="5942160"/>
            <a:ext cx="3240" cy="331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3" name=""/>
          <p:cNvSpPr/>
          <p:nvPr/>
        </p:nvSpPr>
        <p:spPr>
          <a:xfrm>
            <a:off x="4992840" y="5942160"/>
            <a:ext cx="96840" cy="28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"/>
          <p:cNvSpPr/>
          <p:nvPr/>
        </p:nvSpPr>
        <p:spPr>
          <a:xfrm flipV="1">
            <a:off x="5529240" y="5830920"/>
            <a:ext cx="1440" cy="252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"/>
          <p:cNvSpPr/>
          <p:nvPr/>
        </p:nvSpPr>
        <p:spPr>
          <a:xfrm>
            <a:off x="5479920" y="5856120"/>
            <a:ext cx="96840" cy="1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"/>
          <p:cNvSpPr/>
          <p:nvPr/>
        </p:nvSpPr>
        <p:spPr>
          <a:xfrm>
            <a:off x="5529240" y="5881680"/>
            <a:ext cx="1440" cy="237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"/>
          <p:cNvSpPr/>
          <p:nvPr/>
        </p:nvSpPr>
        <p:spPr>
          <a:xfrm>
            <a:off x="5479920" y="5881680"/>
            <a:ext cx="96840" cy="32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"/>
          <p:cNvSpPr/>
          <p:nvPr/>
        </p:nvSpPr>
        <p:spPr>
          <a:xfrm>
            <a:off x="5891040" y="5405400"/>
            <a:ext cx="3240" cy="205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9" name=""/>
          <p:cNvSpPr/>
          <p:nvPr/>
        </p:nvSpPr>
        <p:spPr>
          <a:xfrm>
            <a:off x="5843520" y="5405400"/>
            <a:ext cx="98640" cy="1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0" name=""/>
          <p:cNvSpPr/>
          <p:nvPr/>
        </p:nvSpPr>
        <p:spPr>
          <a:xfrm flipV="1">
            <a:off x="5891040" y="5499000"/>
            <a:ext cx="3240" cy="223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1" name=""/>
          <p:cNvSpPr/>
          <p:nvPr/>
        </p:nvSpPr>
        <p:spPr>
          <a:xfrm>
            <a:off x="5843520" y="5521320"/>
            <a:ext cx="9864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"/>
          <p:cNvSpPr/>
          <p:nvPr/>
        </p:nvSpPr>
        <p:spPr>
          <a:xfrm>
            <a:off x="6380280" y="5118120"/>
            <a:ext cx="1440" cy="302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3" name=""/>
          <p:cNvSpPr/>
          <p:nvPr/>
        </p:nvSpPr>
        <p:spPr>
          <a:xfrm>
            <a:off x="6332400" y="5118120"/>
            <a:ext cx="9684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4" name=""/>
          <p:cNvSpPr/>
          <p:nvPr/>
        </p:nvSpPr>
        <p:spPr>
          <a:xfrm flipV="1">
            <a:off x="6380280" y="5224320"/>
            <a:ext cx="1440" cy="28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5" name=""/>
          <p:cNvSpPr/>
          <p:nvPr/>
        </p:nvSpPr>
        <p:spPr>
          <a:xfrm>
            <a:off x="6332400" y="5253120"/>
            <a:ext cx="96840" cy="32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6" name=""/>
          <p:cNvSpPr/>
          <p:nvPr/>
        </p:nvSpPr>
        <p:spPr>
          <a:xfrm>
            <a:off x="4927680" y="4484520"/>
            <a:ext cx="527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+ vector 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7" name=""/>
          <p:cNvSpPr/>
          <p:nvPr/>
        </p:nvSpPr>
        <p:spPr>
          <a:xfrm>
            <a:off x="4930200" y="4670280"/>
            <a:ext cx="473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+ miR-37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8" name=""/>
          <p:cNvSpPr/>
          <p:nvPr/>
        </p:nvSpPr>
        <p:spPr>
          <a:xfrm>
            <a:off x="4781520" y="4683240"/>
            <a:ext cx="74520" cy="75960"/>
          </a:xfrm>
          <a:prstGeom prst="ellipse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6840" bIns="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9" name=""/>
          <p:cNvSpPr/>
          <p:nvPr/>
        </p:nvSpPr>
        <p:spPr>
          <a:xfrm>
            <a:off x="4781520" y="4497480"/>
            <a:ext cx="74520" cy="75960"/>
          </a:xfrm>
          <a:prstGeom prst="ellipse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6840" bIns="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0" name=""/>
          <p:cNvSpPr/>
          <p:nvPr/>
        </p:nvSpPr>
        <p:spPr>
          <a:xfrm>
            <a:off x="6092640" y="4390920"/>
            <a:ext cx="24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Black"/>
                <a:ea typeface="宋体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1" name=""/>
          <p:cNvSpPr/>
          <p:nvPr/>
        </p:nvSpPr>
        <p:spPr>
          <a:xfrm rot="16200000">
            <a:off x="3396960" y="5194080"/>
            <a:ext cx="1369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Cell number (x 10</a:t>
            </a:r>
            <a:r>
              <a:rPr b="0" lang="en-CA" sz="1000" spc="-1" strike="noStrike" baseline="30000">
                <a:solidFill>
                  <a:srgbClr val="000000"/>
                </a:solidFill>
                <a:latin typeface="Arial"/>
              </a:rPr>
              <a:t>5</a:t>
            </a: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 cells)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2" name=""/>
          <p:cNvSpPr/>
          <p:nvPr/>
        </p:nvSpPr>
        <p:spPr>
          <a:xfrm>
            <a:off x="3574800" y="411156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2000" spc="-1" strike="noStrike">
                <a:solidFill>
                  <a:srgbClr val="000000"/>
                </a:solidFill>
                <a:latin typeface="Arial"/>
                <a:ea typeface="PMingLiU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9-11T16:33:30Z</dcterms:created>
  <dc:creator>byang</dc:creator>
  <dc:description/>
  <dc:language>en-US</dc:language>
  <cp:lastModifiedBy>B. Yang</cp:lastModifiedBy>
  <dcterms:modified xsi:type="dcterms:W3CDTF">2009-10-05T18:11:43Z</dcterms:modified>
  <cp:revision>58</cp:revision>
  <dc:subject/>
  <dc:title>PowerPoint Presentation</dc:title>
</cp:coreProperties>
</file>